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0EBF771-60DB-4727-ABC0-A55E534069C9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EB0334D-0881-40F8-87EB-42130350C830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B3CBE96-C60A-46F8-A75F-40F9AF0AC679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B8C1032-90E4-4984-AF3F-6B2C22F9B9D5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BCE8412-31A0-41A7-BEF7-33D972DF501A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7993960-E893-4839-A108-B9AA6D8A86A1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DF64215-DBEC-4BB0-80D5-420BE152A3A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E7B974D-BC2D-4E8A-AD84-26EA996DEC44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851125F-D939-4ED4-8743-D86811F1A8F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FBAEA89-7FD3-45BC-A436-A773C12FB7D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5C45A9E-854C-440C-AA24-4120ED3641F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E5A9C6D-2197-47FA-803A-D9D7875D8E4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475480"/>
            <a:ext cx="217152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76C3167B-EB57-43AD-BFAC-C80FE6BE3398}" type="slidenum">
              <a:rPr b="0" lang="ja-JP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Group 4"/>
          <p:cNvGrpSpPr/>
          <p:nvPr/>
        </p:nvGrpSpPr>
        <p:grpSpPr>
          <a:xfrm>
            <a:off x="1403280" y="3038400"/>
            <a:ext cx="4066920" cy="1028520"/>
            <a:chOff x="1403280" y="3038400"/>
            <a:chExt cx="4066920" cy="1028520"/>
          </a:xfrm>
        </p:grpSpPr>
        <p:sp>
          <p:nvSpPr>
            <p:cNvPr id="42" name="Text Box 5"/>
            <p:cNvSpPr/>
            <p:nvPr/>
          </p:nvSpPr>
          <p:spPr>
            <a:xfrm>
              <a:off x="1645200" y="3458880"/>
              <a:ext cx="3744000" cy="5857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0                 absent</a:t>
              </a: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	</a:t>
              </a: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          absent     </a:t>
              </a: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	</a:t>
              </a: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   absent             absent           absent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spcBef>
                  <a:spcPts val="49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1                 single</a:t>
              </a: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	</a:t>
              </a: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          partial      </a:t>
              </a: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	</a:t>
              </a: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   partial              partial            present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spcBef>
                  <a:spcPts val="49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2                 multiple</a:t>
              </a: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	</a:t>
              </a: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          massive</a:t>
              </a: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	</a:t>
              </a: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   massive          massive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" name="Text Box 6"/>
            <p:cNvSpPr/>
            <p:nvPr/>
          </p:nvSpPr>
          <p:spPr>
            <a:xfrm>
              <a:off x="1428120" y="3081240"/>
              <a:ext cx="72468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pathological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    </a:t>
              </a: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score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" name="Text Box 7"/>
            <p:cNvSpPr/>
            <p:nvPr/>
          </p:nvSpPr>
          <p:spPr>
            <a:xfrm>
              <a:off x="2208240" y="3081240"/>
              <a:ext cx="60588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follicle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formation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" name="Text Box 8"/>
            <p:cNvSpPr/>
            <p:nvPr/>
          </p:nvSpPr>
          <p:spPr>
            <a:xfrm>
              <a:off x="2786400" y="3081240"/>
              <a:ext cx="70200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epithelial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hyperplasia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" name="Text Box 9"/>
            <p:cNvSpPr/>
            <p:nvPr/>
          </p:nvSpPr>
          <p:spPr>
            <a:xfrm>
              <a:off x="3443400" y="3081240"/>
              <a:ext cx="80100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inflammatory 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cell infiltration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" name="Text Box 10"/>
            <p:cNvSpPr/>
            <p:nvPr/>
          </p:nvSpPr>
          <p:spPr>
            <a:xfrm>
              <a:off x="4243320" y="3081240"/>
              <a:ext cx="54648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parietal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cell loss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" name="Text Box 11"/>
            <p:cNvSpPr/>
            <p:nvPr/>
          </p:nvSpPr>
          <p:spPr>
            <a:xfrm>
              <a:off x="4798800" y="3081240"/>
              <a:ext cx="67140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cyst formation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" name="Line 12"/>
            <p:cNvSpPr/>
            <p:nvPr/>
          </p:nvSpPr>
          <p:spPr>
            <a:xfrm>
              <a:off x="1433160" y="3038400"/>
              <a:ext cx="402120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" name="Line 13"/>
            <p:cNvSpPr/>
            <p:nvPr/>
          </p:nvSpPr>
          <p:spPr>
            <a:xfrm>
              <a:off x="1403280" y="4066920"/>
              <a:ext cx="402084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" name="Line 14"/>
            <p:cNvSpPr/>
            <p:nvPr/>
          </p:nvSpPr>
          <p:spPr>
            <a:xfrm>
              <a:off x="1427040" y="3413160"/>
              <a:ext cx="402120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52" name="Text Box 15"/>
          <p:cNvSpPr/>
          <p:nvPr/>
        </p:nvSpPr>
        <p:spPr>
          <a:xfrm>
            <a:off x="1279440" y="2332080"/>
            <a:ext cx="4273560" cy="428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Arial"/>
                <a:ea typeface="Arial"/>
              </a:rPr>
              <a:t>Table S1.</a:t>
            </a:r>
            <a:r>
              <a:rPr b="0" lang="en-US" sz="1100" spc="-1" strike="noStrike">
                <a:solidFill>
                  <a:srgbClr val="000000"/>
                </a:solidFill>
                <a:latin typeface="Arial"/>
                <a:ea typeface="Arial"/>
              </a:rPr>
              <a:t>  </a:t>
            </a:r>
            <a:r>
              <a:rPr b="1" lang="en-US" sz="1100" spc="-1" strike="noStrike">
                <a:solidFill>
                  <a:srgbClr val="000000"/>
                </a:solidFill>
                <a:latin typeface="Arial"/>
                <a:ea typeface="Arial"/>
              </a:rPr>
              <a:t>The diagnostic criteria for histological examination of the stomach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47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8-06-03T23:31:03Z</dcterms:created>
  <dc:creator>KOJI Hase</dc:creator>
  <dc:description/>
  <dc:language>en-US</dc:language>
  <cp:lastModifiedBy>KOJI Hase</cp:lastModifiedBy>
  <dcterms:modified xsi:type="dcterms:W3CDTF">2008-08-04T21:36:46Z</dcterms:modified>
  <cp:revision>7</cp:revision>
  <dc:subject/>
  <dc:title>スライド 1</dc:title>
</cp:coreProperties>
</file>